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3" r:id="rId2"/>
    <p:sldId id="261" r:id="rId3"/>
    <p:sldId id="258" r:id="rId4"/>
  </p:sldIdLst>
  <p:sldSz cx="6858000" cy="99028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2" userDrawn="1">
          <p15:clr>
            <a:srgbClr val="A4A3A4"/>
          </p15:clr>
        </p15:guide>
        <p15:guide id="2" pos="231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2105" y="-600"/>
      </p:cViewPr>
      <p:guideLst>
        <p:guide orient="horz" pos="3072"/>
        <p:guide pos="231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476" y="1143000"/>
            <a:ext cx="2137048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674393" y="1320602"/>
            <a:ext cx="5512606" cy="3712245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674393" y="5142029"/>
            <a:ext cx="5512606" cy="2126481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935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42260" y="1117832"/>
            <a:ext cx="6172822" cy="7918413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74393" y="3587463"/>
            <a:ext cx="5512606" cy="1471379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674393" y="5142029"/>
            <a:ext cx="5512606" cy="681098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60" y="878668"/>
            <a:ext cx="6170797" cy="101904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42260" y="2152476"/>
            <a:ext cx="6170797" cy="687337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119938" y="5557967"/>
            <a:ext cx="4370391" cy="1107435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119938" y="6665401"/>
            <a:ext cx="4370391" cy="1253012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93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60" y="878668"/>
            <a:ext cx="6170797" cy="101904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42260" y="2168076"/>
            <a:ext cx="2912244" cy="6857772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606888" y="2168076"/>
            <a:ext cx="2912244" cy="6857772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60" y="878668"/>
            <a:ext cx="6170797" cy="101904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42260" y="2064091"/>
            <a:ext cx="3005403" cy="551117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935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42260" y="2677599"/>
            <a:ext cx="3005403" cy="634824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963" y="2053301"/>
            <a:ext cx="3005403" cy="551117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935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963" y="2677599"/>
            <a:ext cx="3005403" cy="634824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42260" y="878668"/>
            <a:ext cx="6170797" cy="101904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6" name="图片占位符 5"/>
          <p:cNvSpPr>
            <a:spLocks noGrp="1"/>
          </p:cNvSpPr>
          <p:nvPr>
            <p:ph type="pic" sz="quarter" idx="13"/>
          </p:nvPr>
        </p:nvSpPr>
        <p:spPr>
          <a:xfrm>
            <a:off x="937800" y="3167888"/>
            <a:ext cx="960203" cy="792062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7" name="图片占位符 5"/>
          <p:cNvSpPr>
            <a:spLocks noGrp="1"/>
          </p:cNvSpPr>
          <p:nvPr>
            <p:ph type="pic" sz="quarter" idx="14"/>
          </p:nvPr>
        </p:nvSpPr>
        <p:spPr>
          <a:xfrm>
            <a:off x="937800" y="4076817"/>
            <a:ext cx="960203" cy="792062"/>
          </a:xfrm>
        </p:spPr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42260" y="2246064"/>
            <a:ext cx="2943902" cy="6655003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72460" y="2246064"/>
            <a:ext cx="2940597" cy="6655003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6/5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5757655" y="1320602"/>
            <a:ext cx="587309" cy="7263311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514401" y="1320602"/>
            <a:ext cx="5158195" cy="7263311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18" Type="http://schemas.openxmlformats.org/officeDocument/2006/relationships/tags" Target="../tags/tag5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ags" Target="../tags/tag4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3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2.xml"/><Relationship Id="rId10" Type="http://schemas.openxmlformats.org/officeDocument/2006/relationships/slideLayout" Target="../slideLayouts/slideLayout10.xml"/><Relationship Id="rId19" Type="http://schemas.openxmlformats.org/officeDocument/2006/relationships/tags" Target="../tags/tag6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5"/>
            </p:custDataLst>
          </p:nvPr>
        </p:nvSpPr>
        <p:spPr>
          <a:xfrm>
            <a:off x="342260" y="878668"/>
            <a:ext cx="6170797" cy="1019047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6"/>
            </p:custDataLst>
          </p:nvPr>
        </p:nvSpPr>
        <p:spPr>
          <a:xfrm>
            <a:off x="342260" y="2152476"/>
            <a:ext cx="6170797" cy="687337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7"/>
            </p:custDataLst>
          </p:nvPr>
        </p:nvSpPr>
        <p:spPr>
          <a:xfrm>
            <a:off x="344285" y="9119433"/>
            <a:ext cx="1518903" cy="4575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6/5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8"/>
            </p:custDataLst>
          </p:nvPr>
        </p:nvSpPr>
        <p:spPr>
          <a:xfrm>
            <a:off x="2315484" y="9119433"/>
            <a:ext cx="2227725" cy="4575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9"/>
            </p:custDataLst>
          </p:nvPr>
        </p:nvSpPr>
        <p:spPr>
          <a:xfrm>
            <a:off x="4994154" y="9119433"/>
            <a:ext cx="1518903" cy="4575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4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6585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5285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935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eg"/><Relationship Id="rId9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2.xml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tiff"/><Relationship Id="rId3" Type="http://schemas.openxmlformats.org/officeDocument/2006/relationships/tags" Target="../tags/tag65.xml"/><Relationship Id="rId21" Type="http://schemas.openxmlformats.org/officeDocument/2006/relationships/image" Target="../media/image20.tiff"/><Relationship Id="rId7" Type="http://schemas.openxmlformats.org/officeDocument/2006/relationships/slideLayout" Target="../slideLayouts/slideLayout2.xml"/><Relationship Id="rId12" Type="http://schemas.openxmlformats.org/officeDocument/2006/relationships/image" Target="../media/image11.jpeg"/><Relationship Id="rId17" Type="http://schemas.openxmlformats.org/officeDocument/2006/relationships/image" Target="../media/image16.tiff"/><Relationship Id="rId25" Type="http://schemas.openxmlformats.org/officeDocument/2006/relationships/image" Target="../media/image24.jpeg"/><Relationship Id="rId2" Type="http://schemas.openxmlformats.org/officeDocument/2006/relationships/tags" Target="../tags/tag64.xml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tags" Target="../tags/tag63.xml"/><Relationship Id="rId6" Type="http://schemas.openxmlformats.org/officeDocument/2006/relationships/tags" Target="../tags/tag68.xml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tags" Target="../tags/tag67.xml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tags" Target="../tags/tag66.xml"/><Relationship Id="rId9" Type="http://schemas.openxmlformats.org/officeDocument/2006/relationships/image" Target="../media/image8.tiff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组合 80"/>
          <p:cNvGrpSpPr/>
          <p:nvPr/>
        </p:nvGrpSpPr>
        <p:grpSpPr>
          <a:xfrm>
            <a:off x="2292985" y="1575753"/>
            <a:ext cx="4847590" cy="2944495"/>
            <a:chOff x="3911" y="1641"/>
            <a:chExt cx="7634" cy="4637"/>
          </a:xfrm>
        </p:grpSpPr>
        <p:pic>
          <p:nvPicPr>
            <p:cNvPr id="2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45" y="1885"/>
              <a:ext cx="4415" cy="4296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5523" y="1813"/>
              <a:ext cx="641" cy="14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FYN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107" y="1897"/>
              <a:ext cx="861" cy="21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CASR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4863" y="2062"/>
              <a:ext cx="861" cy="21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RIMS2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557" y="2287"/>
              <a:ext cx="861" cy="21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LC12A2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4275" y="2569"/>
              <a:ext cx="861" cy="21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CACNG4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4221" y="2865"/>
              <a:ext cx="770" cy="16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LC6A7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3971" y="3182"/>
              <a:ext cx="867" cy="15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CHRNA7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971" y="3540"/>
              <a:ext cx="770" cy="16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KCNH5</a:t>
              </a: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3911" y="3903"/>
              <a:ext cx="855" cy="19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LC11A2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3924" y="4254"/>
              <a:ext cx="855" cy="19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LC5A4</a:t>
              </a: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3997" y="4593"/>
              <a:ext cx="855" cy="19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HCN3</a:t>
              </a: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4105" y="4928"/>
              <a:ext cx="855" cy="19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ATP1A3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4283" y="5220"/>
              <a:ext cx="861" cy="18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LC9C1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4608" y="5476"/>
              <a:ext cx="749" cy="196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P2RX4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4860" y="5693"/>
              <a:ext cx="802" cy="137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ALDOA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5321" y="6014"/>
              <a:ext cx="636" cy="13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PCK1</a:t>
              </a: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5739" y="6107"/>
              <a:ext cx="851" cy="17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TYW1B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6236" y="6159"/>
              <a:ext cx="719" cy="118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TYW1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6661" y="6113"/>
              <a:ext cx="599" cy="134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PIGK</a:t>
              </a: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6959" y="6040"/>
              <a:ext cx="866" cy="16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EIF3H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7411" y="5879"/>
              <a:ext cx="896" cy="14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USP17L3</a:t>
              </a: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7721" y="5675"/>
              <a:ext cx="866" cy="24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USP17L8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7974" y="5381"/>
              <a:ext cx="1110" cy="134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USP17L13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8146" y="5141"/>
              <a:ext cx="896" cy="19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USP17L7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8271" y="4821"/>
              <a:ext cx="940" cy="176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USP17L10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8409" y="4473"/>
              <a:ext cx="816" cy="13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USP17L2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5862" y="1797"/>
              <a:ext cx="641" cy="14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RC</a:t>
              </a: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6156" y="1641"/>
              <a:ext cx="1748" cy="168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algn="l" rtl="0" eaLnBrk="0">
                <a:lnSpc>
                  <a:spcPct val="78000"/>
                </a:lnSpc>
                <a:spcBef>
                  <a:spcPts val="875"/>
                </a:spcBef>
                <a:tabLst>
                  <a:tab pos="204470" algn="l"/>
                </a:tabLst>
              </a:pP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 </a:t>
              </a: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D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eubiquitinase acti</a:t>
              </a:r>
              <a:r>
                <a:rPr sz="600" kern="0" spc="-1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vity</a:t>
              </a:r>
              <a:endParaRPr lang="zh-CN" altLang="en-US" sz="6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+mn-ea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7015" y="1808"/>
              <a:ext cx="2588" cy="164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C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ysteine−type peptidase activity</a:t>
              </a: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7351" y="1996"/>
              <a:ext cx="3157" cy="97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U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biquitin−like protein−specific protease activity</a:t>
              </a: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7691" y="2176"/>
              <a:ext cx="2400" cy="219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C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ysteine−type peptidase activity</a:t>
              </a: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7953" y="2383"/>
              <a:ext cx="2349" cy="12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altLang="zh-CN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Thiol−dependent deubiquitinase</a:t>
              </a:r>
            </a:p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endParaRPr lang="en-US" altLang="zh-CN" sz="600" kern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+mn-ea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8026" y="3557"/>
              <a:ext cx="3391" cy="194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 </a:t>
              </a: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S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odium ion transmembrane transporter activity</a:t>
              </a: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8274" y="2871"/>
              <a:ext cx="2269" cy="10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C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arbon−carbon lyase activity</a:t>
              </a: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8187" y="2614"/>
              <a:ext cx="2115" cy="152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O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mega peptidase activity</a:t>
              </a:r>
            </a:p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endParaRPr sz="600" kern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  <a:sym typeface="+mn-ea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8142" y="3159"/>
              <a:ext cx="3403" cy="11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M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etal ion transmembrane transporter activity</a:t>
              </a: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8331" y="3905"/>
              <a:ext cx="2519" cy="107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marL="29210" lvl="0" algn="l" eaLnBrk="0">
                <a:lnSpc>
                  <a:spcPct val="78000"/>
                </a:lnSpc>
                <a:spcBef>
                  <a:spcPts val="875"/>
                </a:spcBef>
                <a:buClrTx/>
                <a:buSzTx/>
                <a:buFontTx/>
                <a:tabLst>
                  <a:tab pos="204470" algn="l"/>
                </a:tabLst>
              </a:pP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 </a:t>
              </a:r>
              <a:r>
                <a:rPr lang="en-US"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T</a:t>
              </a:r>
              <a:r>
                <a:rPr sz="600" kern="0" dirty="0">
                  <a:solidFill>
                    <a:srgbClr val="000000">
                      <a:alpha val="100000"/>
                    </a:srgbClr>
                  </a:solidFill>
                  <a:latin typeface="Arial" panose="020B0604020202020204"/>
                  <a:ea typeface="Arial" panose="020B0604020202020204"/>
                  <a:cs typeface="Arial" panose="020B0604020202020204"/>
                  <a:sym typeface="+mn-ea"/>
                </a:rPr>
                <a:t>ransmembrane transporter binding</a:t>
              </a:r>
            </a:p>
          </p:txBody>
        </p:sp>
        <p:grpSp>
          <p:nvGrpSpPr>
            <p:cNvPr id="63" name="组合 62"/>
            <p:cNvGrpSpPr/>
            <p:nvPr/>
          </p:nvGrpSpPr>
          <p:grpSpPr>
            <a:xfrm>
              <a:off x="9313" y="5108"/>
              <a:ext cx="1219" cy="1017"/>
              <a:chOff x="15314" y="7844"/>
              <a:chExt cx="3549" cy="2979"/>
            </a:xfrm>
          </p:grpSpPr>
          <p:pic>
            <p:nvPicPr>
              <p:cNvPr id="14" name="picture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rot="21600000">
                <a:off x="15632" y="9060"/>
                <a:ext cx="346" cy="1728"/>
              </a:xfrm>
              <a:prstGeom prst="rect">
                <a:avLst/>
              </a:prstGeom>
            </p:spPr>
          </p:pic>
          <p:sp>
            <p:nvSpPr>
              <p:cNvPr id="24" name="path 24"/>
              <p:cNvSpPr/>
              <p:nvPr/>
            </p:nvSpPr>
            <p:spPr>
              <a:xfrm>
                <a:off x="15628" y="9649"/>
                <a:ext cx="353" cy="598"/>
              </a:xfrm>
              <a:custGeom>
                <a:avLst/>
                <a:gdLst/>
                <a:ahLst/>
                <a:cxnLst/>
                <a:rect l="0" t="0" r="0" b="0"/>
                <a:pathLst>
                  <a:path w="353" h="597">
                    <a:moveTo>
                      <a:pt x="280" y="594"/>
                    </a:moveTo>
                    <a:lnTo>
                      <a:pt x="349" y="594"/>
                    </a:lnTo>
                    <a:moveTo>
                      <a:pt x="280" y="3"/>
                    </a:moveTo>
                    <a:lnTo>
                      <a:pt x="349" y="3"/>
                    </a:lnTo>
                    <a:moveTo>
                      <a:pt x="72" y="594"/>
                    </a:moveTo>
                    <a:lnTo>
                      <a:pt x="3" y="594"/>
                    </a:lnTo>
                    <a:moveTo>
                      <a:pt x="72" y="3"/>
                    </a:moveTo>
                    <a:lnTo>
                      <a:pt x="3" y="3"/>
                    </a:lnTo>
                  </a:path>
                </a:pathLst>
              </a:custGeom>
              <a:noFill/>
              <a:ln w="4699" cap="rnd">
                <a:solidFill>
                  <a:srgbClr val="FFFFFF"/>
                </a:solidFill>
                <a:prstDash val="solid"/>
                <a:round/>
              </a:ln>
            </p:spPr>
            <p:txBody>
              <a:bodyPr rtlCol="0"/>
              <a:lstStyle/>
              <a:p>
                <a:pPr algn="ctr"/>
                <a:endParaRPr lang="zh-CN" altLang="en-US" sz="600"/>
              </a:p>
            </p:txBody>
          </p:sp>
          <p:sp>
            <p:nvSpPr>
              <p:cNvPr id="28" name="textbox 28"/>
              <p:cNvSpPr/>
              <p:nvPr/>
            </p:nvSpPr>
            <p:spPr>
              <a:xfrm>
                <a:off x="15314" y="7844"/>
                <a:ext cx="3549" cy="747"/>
              </a:xfrm>
              <a:prstGeom prst="rect">
                <a:avLst/>
              </a:prstGeom>
              <a:noFill/>
              <a:ln w="0" cap="flat">
                <a:noFill/>
                <a:prstDash val="solid"/>
                <a:miter lim="0"/>
              </a:ln>
            </p:spPr>
            <p:txBody>
              <a:bodyPr vert="horz" wrap="square" lIns="0" tIns="0" rIns="0" bIns="0"/>
              <a:lstStyle/>
              <a:p>
                <a:pPr algn="l" rtl="0" eaLnBrk="0">
                  <a:lnSpc>
                    <a:spcPct val="83000"/>
                  </a:lnSpc>
                </a:pPr>
                <a:endParaRPr sz="600" dirty="0">
                  <a:latin typeface="Arial" panose="020B0604020202020204"/>
                  <a:ea typeface="Arial" panose="020B0604020202020204"/>
                  <a:cs typeface="Arial" panose="020B0604020202020204"/>
                </a:endParaRPr>
              </a:p>
              <a:p>
                <a:pPr marL="12700" algn="l" rtl="0" eaLnBrk="0">
                  <a:lnSpc>
                    <a:spcPts val="1500"/>
                  </a:lnSpc>
                </a:pPr>
                <a:r>
                  <a:rPr lang="en-US" sz="600" kern="0" spc="-20" dirty="0">
                    <a:solidFill>
                      <a:srgbClr val="000000">
                        <a:alpha val="100000"/>
                      </a:srgbClr>
                    </a:solidFill>
                    <a:latin typeface="Arial" panose="020B0604020202020204"/>
                    <a:ea typeface="Arial" panose="020B0604020202020204"/>
                    <a:cs typeface="Arial" panose="020B0604020202020204"/>
                  </a:rPr>
                  <a:t>L</a:t>
                </a:r>
                <a:r>
                  <a:rPr sz="600" kern="0" spc="-20" dirty="0">
                    <a:solidFill>
                      <a:srgbClr val="000000">
                        <a:alpha val="100000"/>
                      </a:srgbClr>
                    </a:solidFill>
                    <a:latin typeface="Arial" panose="020B0604020202020204"/>
                    <a:ea typeface="Arial" panose="020B0604020202020204"/>
                    <a:cs typeface="Arial" panose="020B0604020202020204"/>
                  </a:rPr>
                  <a:t>og2 </a:t>
                </a:r>
                <a:r>
                  <a:rPr lang="en-US" sz="600" kern="0" spc="-20" dirty="0">
                    <a:solidFill>
                      <a:srgbClr val="000000">
                        <a:alpha val="100000"/>
                      </a:srgbClr>
                    </a:solidFill>
                    <a:latin typeface="Arial" panose="020B0604020202020204"/>
                    <a:ea typeface="Arial" panose="020B0604020202020204"/>
                    <a:cs typeface="Arial" panose="020B0604020202020204"/>
                  </a:rPr>
                  <a:t> (fold change)</a:t>
                </a: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15529" y="9498"/>
                <a:ext cx="1806" cy="762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ctr" rtl="0" eaLnBrk="0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600" dirty="0">
                    <a:latin typeface="Arial" panose="020B0604020202020204"/>
                    <a:ea typeface="Arial" panose="020B0604020202020204"/>
                    <a:cs typeface="Arial" panose="020B0604020202020204"/>
                  </a:rPr>
                  <a:t>100</a:t>
                </a: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15529" y="10061"/>
                <a:ext cx="1807" cy="762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ctr" rtl="0" eaLnBrk="0">
                  <a:lnSpc>
                    <a:spcPct val="80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600" dirty="0">
                    <a:latin typeface="Arial" panose="020B0604020202020204"/>
                    <a:ea typeface="Arial" panose="020B0604020202020204"/>
                    <a:cs typeface="Arial" panose="020B0604020202020204"/>
                  </a:rPr>
                  <a:t>50</a:t>
                </a:r>
              </a:p>
            </p:txBody>
          </p:sp>
        </p:grpSp>
        <p:sp>
          <p:nvSpPr>
            <p:cNvPr id="65" name="文本框 64"/>
            <p:cNvSpPr txBox="1"/>
            <p:nvPr/>
          </p:nvSpPr>
          <p:spPr>
            <a:xfrm>
              <a:off x="9053" y="4316"/>
              <a:ext cx="1491" cy="157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Size (gene count)</a:t>
              </a:r>
            </a:p>
          </p:txBody>
        </p:sp>
        <p:grpSp>
          <p:nvGrpSpPr>
            <p:cNvPr id="77" name="组合 76"/>
            <p:cNvGrpSpPr/>
            <p:nvPr/>
          </p:nvGrpSpPr>
          <p:grpSpPr>
            <a:xfrm>
              <a:off x="9368" y="4458"/>
              <a:ext cx="464" cy="620"/>
              <a:chOff x="9308" y="4428"/>
              <a:chExt cx="464" cy="620"/>
            </a:xfrm>
          </p:grpSpPr>
          <p:grpSp>
            <p:nvGrpSpPr>
              <p:cNvPr id="64" name="组合 63"/>
              <p:cNvGrpSpPr/>
              <p:nvPr/>
            </p:nvGrpSpPr>
            <p:grpSpPr>
              <a:xfrm>
                <a:off x="9334" y="4522"/>
                <a:ext cx="122" cy="455"/>
                <a:chOff x="18920" y="4072"/>
                <a:chExt cx="354" cy="1332"/>
              </a:xfrm>
            </p:grpSpPr>
            <p:pic>
              <p:nvPicPr>
                <p:cNvPr id="26" name="picture 26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 rot="21600000">
                  <a:off x="18943" y="4311"/>
                  <a:ext cx="317" cy="659"/>
                </a:xfrm>
                <a:prstGeom prst="rect">
                  <a:avLst/>
                </a:prstGeom>
              </p:spPr>
            </p:pic>
            <p:pic>
              <p:nvPicPr>
                <p:cNvPr id="30" name="picture 30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 rot="21600000">
                  <a:off x="18920" y="5051"/>
                  <a:ext cx="354" cy="353"/>
                </a:xfrm>
                <a:prstGeom prst="rect">
                  <a:avLst/>
                </a:prstGeom>
              </p:spPr>
            </p:pic>
            <p:pic>
              <p:nvPicPr>
                <p:cNvPr id="34" name="picture 34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 rot="21600000">
                  <a:off x="19021" y="4072"/>
                  <a:ext cx="156" cy="156"/>
                </a:xfrm>
                <a:prstGeom prst="rect">
                  <a:avLst/>
                </a:prstGeom>
              </p:spPr>
            </p:pic>
          </p:grpSp>
          <p:grpSp>
            <p:nvGrpSpPr>
              <p:cNvPr id="70" name="组合 69"/>
              <p:cNvGrpSpPr/>
              <p:nvPr/>
            </p:nvGrpSpPr>
            <p:grpSpPr>
              <a:xfrm>
                <a:off x="9308" y="4428"/>
                <a:ext cx="464" cy="620"/>
                <a:chOff x="15168" y="8270"/>
                <a:chExt cx="1352" cy="1813"/>
              </a:xfrm>
            </p:grpSpPr>
            <p:sp>
              <p:nvSpPr>
                <p:cNvPr id="66" name="文本框 65"/>
                <p:cNvSpPr txBox="1"/>
                <p:nvPr/>
              </p:nvSpPr>
              <p:spPr>
                <a:xfrm>
                  <a:off x="15348" y="8270"/>
                  <a:ext cx="901" cy="760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pPr algn="ctr" rtl="0" eaLnBrk="0">
                    <a:lnSpc>
                      <a:spcPct val="80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600" dirty="0">
                      <a:latin typeface="Arial" panose="020B0604020202020204"/>
                      <a:ea typeface="Arial" panose="020B0604020202020204"/>
                      <a:cs typeface="Arial" panose="020B0604020202020204"/>
                    </a:rPr>
                    <a:t>2</a:t>
                  </a:r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15348" y="8588"/>
                  <a:ext cx="901" cy="760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pPr algn="ctr" rtl="0" eaLnBrk="0">
                    <a:lnSpc>
                      <a:spcPct val="80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600" dirty="0">
                      <a:latin typeface="Arial" panose="020B0604020202020204"/>
                      <a:ea typeface="Arial" panose="020B0604020202020204"/>
                      <a:cs typeface="Arial" panose="020B0604020202020204"/>
                    </a:rPr>
                    <a:t>4</a:t>
                  </a:r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15348" y="8949"/>
                  <a:ext cx="901" cy="760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pPr algn="ctr" rtl="0" eaLnBrk="0">
                    <a:lnSpc>
                      <a:spcPct val="80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600" dirty="0">
                      <a:latin typeface="Arial" panose="020B0604020202020204"/>
                      <a:ea typeface="Arial" panose="020B0604020202020204"/>
                      <a:cs typeface="Arial" panose="020B0604020202020204"/>
                    </a:rPr>
                    <a:t>8</a:t>
                  </a:r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15168" y="9323"/>
                  <a:ext cx="1352" cy="760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pPr algn="ctr" rtl="0" eaLnBrk="0">
                    <a:lnSpc>
                      <a:spcPct val="80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600" dirty="0">
                      <a:latin typeface="Arial" panose="020B0604020202020204"/>
                      <a:ea typeface="Arial" panose="020B0604020202020204"/>
                      <a:cs typeface="Arial" panose="020B0604020202020204"/>
                    </a:rPr>
                    <a:t>10</a:t>
                  </a:r>
                </a:p>
              </p:txBody>
            </p:sp>
          </p:grpSp>
        </p:grpSp>
      </p:grpSp>
      <p:grpSp>
        <p:nvGrpSpPr>
          <p:cNvPr id="75" name="组合 74"/>
          <p:cNvGrpSpPr/>
          <p:nvPr/>
        </p:nvGrpSpPr>
        <p:grpSpPr>
          <a:xfrm>
            <a:off x="-52070" y="1556703"/>
            <a:ext cx="3210560" cy="3193886"/>
            <a:chOff x="361" y="3363"/>
            <a:chExt cx="9216" cy="9852"/>
          </a:xfrm>
        </p:grpSpPr>
        <p:grpSp>
          <p:nvGrpSpPr>
            <p:cNvPr id="22" name="组合 21"/>
            <p:cNvGrpSpPr/>
            <p:nvPr/>
          </p:nvGrpSpPr>
          <p:grpSpPr>
            <a:xfrm>
              <a:off x="361" y="12324"/>
              <a:ext cx="9216" cy="890"/>
              <a:chOff x="361" y="12380"/>
              <a:chExt cx="9216" cy="870"/>
            </a:xfrm>
          </p:grpSpPr>
          <p:sp>
            <p:nvSpPr>
              <p:cNvPr id="7" name="文本框 6"/>
              <p:cNvSpPr txBox="1"/>
              <p:nvPr/>
            </p:nvSpPr>
            <p:spPr>
              <a:xfrm>
                <a:off x="2644" y="12697"/>
                <a:ext cx="3710" cy="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" panose="020B0604020202020204" pitchFamily="34" charset="0"/>
                    <a:cs typeface="Arial" panose="020B0604020202020204" pitchFamily="34" charset="0"/>
                  </a:rPr>
                  <a:t>Enrichment Score</a:t>
                </a:r>
              </a:p>
            </p:txBody>
          </p:sp>
          <p:grpSp>
            <p:nvGrpSpPr>
              <p:cNvPr id="12" name="组合 11"/>
              <p:cNvGrpSpPr/>
              <p:nvPr/>
            </p:nvGrpSpPr>
            <p:grpSpPr>
              <a:xfrm>
                <a:off x="361" y="12380"/>
                <a:ext cx="9216" cy="554"/>
                <a:chOff x="7946" y="7908"/>
                <a:chExt cx="6232" cy="383"/>
              </a:xfrm>
            </p:grpSpPr>
            <p:sp>
              <p:nvSpPr>
                <p:cNvPr id="8" name="文本框 7"/>
                <p:cNvSpPr txBox="1"/>
                <p:nvPr/>
              </p:nvSpPr>
              <p:spPr>
                <a:xfrm>
                  <a:off x="8800" y="7908"/>
                  <a:ext cx="196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9" name="文本框 8"/>
                <p:cNvSpPr txBox="1"/>
                <p:nvPr/>
              </p:nvSpPr>
              <p:spPr>
                <a:xfrm>
                  <a:off x="9654" y="7908"/>
                  <a:ext cx="196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0" name="文本框 9"/>
                <p:cNvSpPr txBox="1"/>
                <p:nvPr/>
              </p:nvSpPr>
              <p:spPr>
                <a:xfrm>
                  <a:off x="10508" y="7908"/>
                  <a:ext cx="196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6" name="文本框 15"/>
                <p:cNvSpPr txBox="1"/>
                <p:nvPr/>
              </p:nvSpPr>
              <p:spPr>
                <a:xfrm>
                  <a:off x="11362" y="7908"/>
                  <a:ext cx="196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12216" y="7908"/>
                  <a:ext cx="196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>
                  <a:off x="7946" y="7908"/>
                  <a:ext cx="196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</p:grpSp>
        <p:graphicFrame>
          <p:nvGraphicFramePr>
            <p:cNvPr id="32" name="对象 31"/>
            <p:cNvGraphicFramePr>
              <a:graphicFrameLocks noChangeAspect="1"/>
            </p:cNvGraphicFramePr>
            <p:nvPr/>
          </p:nvGraphicFramePr>
          <p:xfrm>
            <a:off x="517" y="3363"/>
            <a:ext cx="6689" cy="92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743325" imgH="5295900" progId="Prism10.Document">
                    <p:embed/>
                  </p:oleObj>
                </mc:Choice>
                <mc:Fallback>
                  <p:oleObj name="Prism 10" r:id="rId8" imgW="3743325" imgH="5295900" progId="Prism10.Document">
                    <p:embed/>
                    <p:pic>
                      <p:nvPicPr>
                        <p:cNvPr id="0" name="图片 2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17" y="3363"/>
                          <a:ext cx="6689" cy="92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8" name="文本框 77"/>
          <p:cNvSpPr txBox="1"/>
          <p:nvPr/>
        </p:nvSpPr>
        <p:spPr>
          <a:xfrm>
            <a:off x="-52070" y="1048385"/>
            <a:ext cx="1889760" cy="2387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 rtl="0" ea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 dirty="0">
                <a:latin typeface="Arial" panose="020B0604020202020204"/>
                <a:ea typeface="Arial" panose="020B0604020202020204"/>
                <a:cs typeface="Arial" panose="020B0604020202020204"/>
              </a:rPr>
              <a:t>Fig. S1</a:t>
            </a:r>
          </a:p>
        </p:txBody>
      </p:sp>
      <p:sp>
        <p:nvSpPr>
          <p:cNvPr id="79" name="文本框 78"/>
          <p:cNvSpPr txBox="1"/>
          <p:nvPr/>
        </p:nvSpPr>
        <p:spPr>
          <a:xfrm>
            <a:off x="-52070" y="1397318"/>
            <a:ext cx="325755" cy="2387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 rtl="0" ea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dirty="0">
                <a:latin typeface="Arial" panose="020B0604020202020204"/>
                <a:ea typeface="Arial" panose="020B0604020202020204"/>
                <a:cs typeface="Arial" panose="020B0604020202020204"/>
              </a:rPr>
              <a:t>A</a:t>
            </a:r>
          </a:p>
        </p:txBody>
      </p:sp>
      <p:sp>
        <p:nvSpPr>
          <p:cNvPr id="80" name="文本框 79"/>
          <p:cNvSpPr txBox="1"/>
          <p:nvPr/>
        </p:nvSpPr>
        <p:spPr>
          <a:xfrm>
            <a:off x="1843405" y="1397318"/>
            <a:ext cx="1400175" cy="2387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 rtl="0" ea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dirty="0">
                <a:latin typeface="Arial" panose="020B0604020202020204"/>
                <a:ea typeface="Arial" panose="020B0604020202020204"/>
                <a:cs typeface="Arial" panose="020B0604020202020204"/>
              </a:rPr>
              <a:t>B</a:t>
            </a:r>
          </a:p>
        </p:txBody>
      </p:sp>
      <p:grpSp>
        <p:nvGrpSpPr>
          <p:cNvPr id="94" name="组合 93"/>
          <p:cNvGrpSpPr/>
          <p:nvPr/>
        </p:nvGrpSpPr>
        <p:grpSpPr>
          <a:xfrm>
            <a:off x="1838325" y="4143058"/>
            <a:ext cx="152400" cy="231775"/>
            <a:chOff x="2203" y="986"/>
            <a:chExt cx="240" cy="624"/>
          </a:xfrm>
        </p:grpSpPr>
        <p:sp>
          <p:nvSpPr>
            <p:cNvPr id="84" name="矩形 83"/>
            <p:cNvSpPr/>
            <p:nvPr/>
          </p:nvSpPr>
          <p:spPr>
            <a:xfrm>
              <a:off x="2203" y="986"/>
              <a:ext cx="240" cy="119"/>
            </a:xfrm>
            <a:prstGeom prst="rect">
              <a:avLst/>
            </a:prstGeom>
            <a:solidFill>
              <a:srgbClr val="FFA0A0"/>
            </a:solidFill>
            <a:ln w="12700" cmpd="sng">
              <a:solidFill>
                <a:srgbClr val="FFA0A0"/>
              </a:solidFill>
              <a:prstDash val="solid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" name="矩形 84"/>
            <p:cNvSpPr/>
            <p:nvPr/>
          </p:nvSpPr>
          <p:spPr>
            <a:xfrm>
              <a:off x="2203" y="1239"/>
              <a:ext cx="240" cy="119"/>
            </a:xfrm>
            <a:prstGeom prst="rect">
              <a:avLst/>
            </a:prstGeom>
            <a:solidFill>
              <a:srgbClr val="B6EAD7"/>
            </a:solidFill>
            <a:ln>
              <a:solidFill>
                <a:srgbClr val="B6EAD7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6" name="矩形 85"/>
            <p:cNvSpPr/>
            <p:nvPr/>
          </p:nvSpPr>
          <p:spPr>
            <a:xfrm>
              <a:off x="2203" y="1492"/>
              <a:ext cx="240" cy="119"/>
            </a:xfrm>
            <a:prstGeom prst="rect">
              <a:avLst/>
            </a:prstGeom>
            <a:solidFill>
              <a:srgbClr val="8BABD3"/>
            </a:solidFill>
            <a:ln>
              <a:solidFill>
                <a:srgbClr val="8BABD3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2" name="组合 91"/>
          <p:cNvGrpSpPr/>
          <p:nvPr/>
        </p:nvGrpSpPr>
        <p:grpSpPr>
          <a:xfrm>
            <a:off x="1936750" y="4075748"/>
            <a:ext cx="452120" cy="371749"/>
            <a:chOff x="2584" y="815"/>
            <a:chExt cx="712" cy="1036"/>
          </a:xfrm>
        </p:grpSpPr>
        <p:sp>
          <p:nvSpPr>
            <p:cNvPr id="87" name="文本框 86"/>
            <p:cNvSpPr txBox="1"/>
            <p:nvPr/>
          </p:nvSpPr>
          <p:spPr>
            <a:xfrm>
              <a:off x="2584" y="815"/>
              <a:ext cx="712" cy="46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MF</a:t>
              </a: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2584" y="1103"/>
              <a:ext cx="712" cy="46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CC</a:t>
              </a: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2584" y="1391"/>
              <a:ext cx="712" cy="460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 rtl="0" eaLnBrk="0">
                <a:lnSpc>
                  <a:spcPct val="8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600" dirty="0">
                  <a:latin typeface="Arial" panose="020B0604020202020204"/>
                  <a:ea typeface="Arial" panose="020B0604020202020204"/>
                  <a:cs typeface="Arial" panose="020B0604020202020204"/>
                </a:rPr>
                <a:t>BP</a:t>
              </a:r>
            </a:p>
          </p:txBody>
        </p:sp>
      </p:grpSp>
      <p:sp>
        <p:nvSpPr>
          <p:cNvPr id="4" name="文本框 3"/>
          <p:cNvSpPr txBox="1"/>
          <p:nvPr/>
        </p:nvSpPr>
        <p:spPr>
          <a:xfrm>
            <a:off x="177800" y="5561330"/>
            <a:ext cx="6398895" cy="15684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 rtl="0" ea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 dirty="0">
                <a:latin typeface="Arial" panose="020B0604020202020204"/>
                <a:ea typeface="Arial" panose="020B0604020202020204"/>
                <a:cs typeface="Arial" panose="020B0604020202020204"/>
              </a:rPr>
              <a:t>Figure. S1. Gene ontology (GO) enrichment analysis of differentially expressed genes.</a:t>
            </a:r>
            <a:r>
              <a:rPr lang="en-US" altLang="zh-CN" sz="1200" dirty="0"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</a:p>
          <a:p>
            <a:pPr algn="just" rtl="0" eaLnBrk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dirty="0">
                <a:latin typeface="Arial" panose="020B0604020202020204"/>
                <a:ea typeface="Arial" panose="020B0604020202020204"/>
                <a:cs typeface="Arial" panose="020B0604020202020204"/>
              </a:rPr>
              <a:t>(A) Distribution of significantly enriched GO terms. The horizontal bar plot displays the top 10 enriched functional categories categorized into three domains: Molecular Function (MF, pink), Cellular Component (CC, green), and Biological Process (BP, blue). The x-axis represents the enrichment score, indicating the degree of over-representation for each term. (B) Gene-concept network (cnetplot) of key functional pathways. This network illustrates the linkages between specific differentially expressed genes (DEGs) and their associated GO term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-635" y="6922135"/>
            <a:ext cx="67818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. S2. Bubble plot showing the top GO terms enriched in USP17L13-overexpressing cells.</a:t>
            </a:r>
          </a:p>
          <a:p>
            <a:r>
              <a:rPr lang="en-US" altLang="zh-CN" sz="1200" dirty="0"/>
              <a:t>Gene set enrichment analysis (GSEA) was carried out on transcriptomic data from USP17L13-overexpressing cells and vector control cells, and the most significantly enriched gene ontology (GO) terms are presented. The x-axis shows the </a:t>
            </a:r>
            <a:r>
              <a:rPr lang="en-US" altLang="zh-CN" sz="1200" dirty="0" err="1"/>
              <a:t>GeneRatio</a:t>
            </a:r>
            <a:r>
              <a:rPr lang="en-US" altLang="zh-CN" sz="1200" dirty="0"/>
              <a:t>, whereas the y-axis lists the enriched GO terms. Bubble size reflects the number of genes included in each term, and bubble color corresponds to the adjusted P value.</a:t>
            </a:r>
          </a:p>
        </p:txBody>
      </p:sp>
      <p:pic>
        <p:nvPicPr>
          <p:cNvPr id="6" name="图片 5" descr="L13_PR8-vs-V_PR8_GSEA_GO_enrich_dotplot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97025"/>
            <a:ext cx="6638925" cy="5107305"/>
          </a:xfrm>
          <a:prstGeom prst="rect">
            <a:avLst/>
          </a:prstGeom>
        </p:spPr>
      </p:pic>
      <p:sp>
        <p:nvSpPr>
          <p:cNvPr id="78" name="文本框 77"/>
          <p:cNvSpPr txBox="1"/>
          <p:nvPr/>
        </p:nvSpPr>
        <p:spPr>
          <a:xfrm>
            <a:off x="-52070" y="1442085"/>
            <a:ext cx="1889760" cy="2387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 rtl="0" ea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 dirty="0">
                <a:latin typeface="Arial" panose="020B0604020202020204"/>
                <a:ea typeface="Arial" panose="020B0604020202020204"/>
                <a:cs typeface="Arial" panose="020B0604020202020204"/>
              </a:rPr>
              <a:t>Fig. S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组合 49"/>
          <p:cNvGrpSpPr/>
          <p:nvPr/>
        </p:nvGrpSpPr>
        <p:grpSpPr>
          <a:xfrm>
            <a:off x="865500" y="1730375"/>
            <a:ext cx="571963" cy="1149194"/>
            <a:chOff x="904887" y="1758685"/>
            <a:chExt cx="750429" cy="1508063"/>
          </a:xfrm>
        </p:grpSpPr>
        <p:grpSp>
          <p:nvGrpSpPr>
            <p:cNvPr id="43" name="组合 42"/>
            <p:cNvGrpSpPr/>
            <p:nvPr/>
          </p:nvGrpSpPr>
          <p:grpSpPr>
            <a:xfrm>
              <a:off x="1446893" y="1870874"/>
              <a:ext cx="208423" cy="1301996"/>
              <a:chOff x="1477291" y="1867561"/>
              <a:chExt cx="208423" cy="1301996"/>
            </a:xfrm>
          </p:grpSpPr>
          <p:cxnSp>
            <p:nvCxnSpPr>
              <p:cNvPr id="38" name="直接连接符 37"/>
              <p:cNvCxnSpPr/>
              <p:nvPr/>
            </p:nvCxnSpPr>
            <p:spPr>
              <a:xfrm>
                <a:off x="1477291" y="18675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477291" y="2337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1477291" y="3169557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1477291" y="2718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组合 48"/>
            <p:cNvGrpSpPr/>
            <p:nvPr/>
          </p:nvGrpSpPr>
          <p:grpSpPr>
            <a:xfrm>
              <a:off x="904887" y="1758685"/>
              <a:ext cx="643399" cy="1508063"/>
              <a:chOff x="904887" y="1758685"/>
              <a:chExt cx="643399" cy="1508063"/>
            </a:xfrm>
          </p:grpSpPr>
          <p:sp>
            <p:nvSpPr>
              <p:cNvPr id="44" name="文本框 43"/>
              <p:cNvSpPr txBox="1"/>
              <p:nvPr/>
            </p:nvSpPr>
            <p:spPr>
              <a:xfrm>
                <a:off x="990918" y="1758685"/>
                <a:ext cx="557368" cy="4899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130</a:t>
                </a:r>
                <a:endParaRPr lang="zh-CN" altLang="en-US" sz="915" dirty="0"/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904887" y="2195333"/>
                <a:ext cx="624852" cy="3049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100</a:t>
                </a:r>
                <a:endParaRPr lang="zh-CN" altLang="en-US" sz="915" dirty="0"/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1084880" y="2585708"/>
                <a:ext cx="445293" cy="2324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45</a:t>
                </a:r>
                <a:endParaRPr lang="zh-CN" altLang="en-US" sz="915" dirty="0"/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1084851" y="3034328"/>
                <a:ext cx="445293" cy="2324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35</a:t>
                </a:r>
                <a:endParaRPr lang="zh-CN" altLang="en-US" sz="915" dirty="0"/>
              </a:p>
            </p:txBody>
          </p:sp>
        </p:grpSp>
      </p:grpSp>
      <p:pic>
        <p:nvPicPr>
          <p:cNvPr id="32" name="图片 3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2" t="40264" r="55920" b="23283"/>
          <a:stretch>
            <a:fillRect/>
          </a:stretch>
        </p:blipFill>
        <p:spPr>
          <a:xfrm flipH="1" flipV="1">
            <a:off x="1257687" y="1707939"/>
            <a:ext cx="932982" cy="548756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01" t="48142" r="44341" b="6475"/>
          <a:stretch>
            <a:fillRect/>
          </a:stretch>
        </p:blipFill>
        <p:spPr>
          <a:xfrm flipH="1" flipV="1">
            <a:off x="5254993" y="3756339"/>
            <a:ext cx="932982" cy="548756"/>
          </a:xfrm>
          <a:prstGeom prst="rect">
            <a:avLst/>
          </a:prstGeom>
        </p:spPr>
      </p:pic>
      <p:graphicFrame>
        <p:nvGraphicFramePr>
          <p:cNvPr id="162" name="表格 161"/>
          <p:cNvGraphicFramePr/>
          <p:nvPr>
            <p:custDataLst>
              <p:tags r:id="rId2"/>
            </p:custDataLst>
          </p:nvPr>
        </p:nvGraphicFramePr>
        <p:xfrm>
          <a:off x="3566928" y="2988408"/>
          <a:ext cx="2571750" cy="680720"/>
        </p:xfrm>
        <a:graphic>
          <a:graphicData uri="http://schemas.openxmlformats.org/drawingml/2006/table">
            <a:tbl>
              <a:tblPr/>
              <a:tblGrid>
                <a:gridCol w="908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62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36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086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52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765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dirty="0">
                          <a:sym typeface="+mn-ea"/>
                        </a:rPr>
                        <a:t>IKK</a:t>
                      </a:r>
                      <a:r>
                        <a:rPr lang="el-GR" altLang="zh-CN" sz="1065" dirty="0">
                          <a:sym typeface="+mn-ea"/>
                        </a:rPr>
                        <a:t>ε</a:t>
                      </a:r>
                      <a:r>
                        <a:rPr lang="en-US" altLang="el-GR" sz="1065" dirty="0">
                          <a:sym typeface="+mn-ea"/>
                        </a:rPr>
                        <a:t>-Flag</a:t>
                      </a:r>
                      <a:endParaRPr lang="en-US" altLang="el-GR" sz="1065" b="0" i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13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2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ector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212" name="文本框 211"/>
          <p:cNvSpPr txBox="1"/>
          <p:nvPr/>
        </p:nvSpPr>
        <p:spPr>
          <a:xfrm>
            <a:off x="291465" y="621665"/>
            <a:ext cx="141541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/>
              <a:t>Fig. S3</a:t>
            </a:r>
          </a:p>
        </p:txBody>
      </p:sp>
      <p:graphicFrame>
        <p:nvGraphicFramePr>
          <p:cNvPr id="34" name="表格 33"/>
          <p:cNvGraphicFramePr/>
          <p:nvPr>
            <p:custDataLst>
              <p:tags r:id="rId3"/>
            </p:custDataLst>
          </p:nvPr>
        </p:nvGraphicFramePr>
        <p:xfrm>
          <a:off x="3566928" y="983077"/>
          <a:ext cx="2546985" cy="680720"/>
        </p:xfrm>
        <a:graphic>
          <a:graphicData uri="http://schemas.openxmlformats.org/drawingml/2006/table">
            <a:tbl>
              <a:tblPr/>
              <a:tblGrid>
                <a:gridCol w="8851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84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27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2608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857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587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DA5-HA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13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2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ector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5" name="文本框 76"/>
          <p:cNvSpPr txBox="1"/>
          <p:nvPr/>
        </p:nvSpPr>
        <p:spPr>
          <a:xfrm>
            <a:off x="3566928" y="1888410"/>
            <a:ext cx="526020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HA</a:t>
            </a:r>
          </a:p>
        </p:txBody>
      </p:sp>
      <p:sp>
        <p:nvSpPr>
          <p:cNvPr id="36" name="文本框 77"/>
          <p:cNvSpPr txBox="1"/>
          <p:nvPr/>
        </p:nvSpPr>
        <p:spPr>
          <a:xfrm>
            <a:off x="3566928" y="2471638"/>
            <a:ext cx="701682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GAPDH</a:t>
            </a:r>
          </a:p>
        </p:txBody>
      </p:sp>
      <p:sp>
        <p:nvSpPr>
          <p:cNvPr id="60" name="文本框 76"/>
          <p:cNvSpPr txBox="1"/>
          <p:nvPr/>
        </p:nvSpPr>
        <p:spPr>
          <a:xfrm>
            <a:off x="538897" y="1876736"/>
            <a:ext cx="526020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HA</a:t>
            </a:r>
          </a:p>
        </p:txBody>
      </p:sp>
      <p:sp>
        <p:nvSpPr>
          <p:cNvPr id="61" name="文本框 77"/>
          <p:cNvSpPr txBox="1"/>
          <p:nvPr/>
        </p:nvSpPr>
        <p:spPr>
          <a:xfrm>
            <a:off x="538897" y="2524838"/>
            <a:ext cx="701682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GAPDH</a:t>
            </a:r>
          </a:p>
        </p:txBody>
      </p:sp>
      <p:sp>
        <p:nvSpPr>
          <p:cNvPr id="167" name="文本框 76"/>
          <p:cNvSpPr txBox="1"/>
          <p:nvPr/>
        </p:nvSpPr>
        <p:spPr>
          <a:xfrm>
            <a:off x="538897" y="4033602"/>
            <a:ext cx="526020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HA</a:t>
            </a:r>
          </a:p>
        </p:txBody>
      </p:sp>
      <p:sp>
        <p:nvSpPr>
          <p:cNvPr id="168" name="文本框 77"/>
          <p:cNvSpPr txBox="1"/>
          <p:nvPr/>
        </p:nvSpPr>
        <p:spPr>
          <a:xfrm>
            <a:off x="538897" y="4402350"/>
            <a:ext cx="701682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GAPDH</a:t>
            </a:r>
          </a:p>
        </p:txBody>
      </p:sp>
      <p:sp>
        <p:nvSpPr>
          <p:cNvPr id="169" name="文本框 76"/>
          <p:cNvSpPr txBox="1"/>
          <p:nvPr/>
        </p:nvSpPr>
        <p:spPr>
          <a:xfrm>
            <a:off x="3566928" y="4049442"/>
            <a:ext cx="526020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Flag</a:t>
            </a:r>
          </a:p>
        </p:txBody>
      </p:sp>
      <p:sp>
        <p:nvSpPr>
          <p:cNvPr id="170" name="文本框 77"/>
          <p:cNvSpPr txBox="1"/>
          <p:nvPr/>
        </p:nvSpPr>
        <p:spPr>
          <a:xfrm>
            <a:off x="3566928" y="4415769"/>
            <a:ext cx="701682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β-actin</a:t>
            </a:r>
            <a:endParaRPr lang="zh-CN" altLang="en-US" sz="1065" dirty="0"/>
          </a:p>
        </p:txBody>
      </p:sp>
      <p:graphicFrame>
        <p:nvGraphicFramePr>
          <p:cNvPr id="190" name="表格 189"/>
          <p:cNvGraphicFramePr/>
          <p:nvPr>
            <p:custDataLst>
              <p:tags r:id="rId4"/>
            </p:custDataLst>
          </p:nvPr>
        </p:nvGraphicFramePr>
        <p:xfrm>
          <a:off x="538897" y="5115230"/>
          <a:ext cx="2643505" cy="680720"/>
        </p:xfrm>
        <a:graphic>
          <a:graphicData uri="http://schemas.openxmlformats.org/drawingml/2006/table">
            <a:tbl>
              <a:tblPr/>
              <a:tblGrid>
                <a:gridCol w="10325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27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40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6799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4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178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TING-Myc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13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2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ector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96" name="文本框 76"/>
          <p:cNvSpPr txBox="1"/>
          <p:nvPr/>
        </p:nvSpPr>
        <p:spPr>
          <a:xfrm>
            <a:off x="538897" y="6455403"/>
            <a:ext cx="667798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Myc</a:t>
            </a:r>
          </a:p>
        </p:txBody>
      </p:sp>
      <p:sp>
        <p:nvSpPr>
          <p:cNvPr id="197" name="文本框 77"/>
          <p:cNvSpPr txBox="1"/>
          <p:nvPr/>
        </p:nvSpPr>
        <p:spPr>
          <a:xfrm>
            <a:off x="538897" y="6094124"/>
            <a:ext cx="701682" cy="2552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65" dirty="0"/>
              <a:t>Tubulin</a:t>
            </a:r>
          </a:p>
        </p:txBody>
      </p:sp>
      <p:sp>
        <p:nvSpPr>
          <p:cNvPr id="198" name="文本框 197"/>
          <p:cNvSpPr txBox="1"/>
          <p:nvPr/>
        </p:nvSpPr>
        <p:spPr>
          <a:xfrm>
            <a:off x="338455" y="7174865"/>
            <a:ext cx="6280150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/>
              <a:t>Figure. </a:t>
            </a:r>
            <a:r>
              <a:rPr lang="en-US" altLang="zh-CN" sz="1200" b="1" dirty="0"/>
              <a:t>S3. Degradative effects of USP17L13 on key factors in the IFN signaling pathway</a:t>
            </a:r>
            <a:r>
              <a:rPr lang="en-US" altLang="zh-CN" sz="1200" dirty="0"/>
              <a:t>. HEK293T cells were co-transfected with expression plasmids encoding key proteins in the IFN signaling pathway (RIG-I-HA, MDA5-HA, MAVS-HA, </a:t>
            </a:r>
            <a:r>
              <a:rPr lang="en-US" altLang="zh-CN" sz="1200" dirty="0" err="1"/>
              <a:t>IKKε</a:t>
            </a:r>
            <a:r>
              <a:rPr lang="en-US" altLang="zh-CN" sz="1200" dirty="0"/>
              <a:t>-Flag, and STING-</a:t>
            </a:r>
            <a:r>
              <a:rPr lang="en-US" altLang="zh-CN" sz="1200" dirty="0" err="1"/>
              <a:t>Myc</a:t>
            </a:r>
            <a:r>
              <a:rPr lang="en-US" altLang="zh-CN" sz="1200" dirty="0"/>
              <a:t>), together with either USP17L13-Flag, USP17L2-Flag, or an empty vector control. Protein levels were analyzed by Western blot using anti-HA, anti-Flag, and anti-</a:t>
            </a:r>
            <a:r>
              <a:rPr lang="en-US" altLang="zh-CN" sz="1200" dirty="0" err="1"/>
              <a:t>Myc</a:t>
            </a:r>
            <a:r>
              <a:rPr lang="en-US" altLang="zh-CN" sz="1200" dirty="0"/>
              <a:t> antibodies. GAPDH, β-actin and tubulin were used as loading controls.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8" t="9521" r="54431" b="33284"/>
          <a:stretch>
            <a:fillRect/>
          </a:stretch>
        </p:blipFill>
        <p:spPr>
          <a:xfrm flipH="1" flipV="1">
            <a:off x="1257687" y="2294441"/>
            <a:ext cx="931530" cy="54875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8" t="17148" r="77510" b="39551"/>
          <a:stretch>
            <a:fillRect/>
          </a:stretch>
        </p:blipFill>
        <p:spPr>
          <a:xfrm flipH="1" flipV="1">
            <a:off x="2307776" y="2294441"/>
            <a:ext cx="932982" cy="54875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334" r="78648" b="28961"/>
          <a:stretch>
            <a:fillRect/>
          </a:stretch>
        </p:blipFill>
        <p:spPr>
          <a:xfrm flipH="1" flipV="1">
            <a:off x="2307776" y="1707939"/>
            <a:ext cx="932982" cy="54875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941705" y="1600200"/>
            <a:ext cx="434975" cy="2324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5"/>
              <a:t>kDa</a:t>
            </a:r>
          </a:p>
        </p:txBody>
      </p:sp>
      <p:grpSp>
        <p:nvGrpSpPr>
          <p:cNvPr id="51" name="组合 50"/>
          <p:cNvGrpSpPr/>
          <p:nvPr/>
        </p:nvGrpSpPr>
        <p:grpSpPr>
          <a:xfrm>
            <a:off x="3802375" y="1753235"/>
            <a:ext cx="579583" cy="1119549"/>
            <a:chOff x="894889" y="1847585"/>
            <a:chExt cx="760427" cy="1469164"/>
          </a:xfrm>
        </p:grpSpPr>
        <p:grpSp>
          <p:nvGrpSpPr>
            <p:cNvPr id="52" name="组合 51"/>
            <p:cNvGrpSpPr/>
            <p:nvPr/>
          </p:nvGrpSpPr>
          <p:grpSpPr>
            <a:xfrm>
              <a:off x="1446893" y="1870874"/>
              <a:ext cx="208423" cy="1301996"/>
              <a:chOff x="1477291" y="1867561"/>
              <a:chExt cx="208423" cy="1301996"/>
            </a:xfrm>
          </p:grpSpPr>
          <p:cxnSp>
            <p:nvCxnSpPr>
              <p:cNvPr id="58" name="直接连接符 57"/>
              <p:cNvCxnSpPr/>
              <p:nvPr/>
            </p:nvCxnSpPr>
            <p:spPr>
              <a:xfrm>
                <a:off x="1477291" y="18675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1477291" y="2337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/>
              <p:cNvCxnSpPr/>
              <p:nvPr/>
            </p:nvCxnSpPr>
            <p:spPr>
              <a:xfrm>
                <a:off x="1477291" y="3169557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/>
              <p:nvPr/>
            </p:nvCxnSpPr>
            <p:spPr>
              <a:xfrm>
                <a:off x="1477291" y="2718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" name="组合 52"/>
            <p:cNvGrpSpPr/>
            <p:nvPr/>
          </p:nvGrpSpPr>
          <p:grpSpPr>
            <a:xfrm>
              <a:off x="894889" y="1847585"/>
              <a:ext cx="650679" cy="1469164"/>
              <a:chOff x="894889" y="1847585"/>
              <a:chExt cx="650679" cy="1469164"/>
            </a:xfrm>
          </p:grpSpPr>
          <p:sp>
            <p:nvSpPr>
              <p:cNvPr id="54" name="文本框 53"/>
              <p:cNvSpPr txBox="1"/>
              <p:nvPr/>
            </p:nvSpPr>
            <p:spPr>
              <a:xfrm>
                <a:off x="894889" y="1847585"/>
                <a:ext cx="650679" cy="3049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180</a:t>
                </a:r>
                <a:endParaRPr lang="zh-CN" altLang="en-US" sz="915" dirty="0"/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951905" y="2135071"/>
                <a:ext cx="592359" cy="3049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130</a:t>
                </a:r>
                <a:endParaRPr lang="zh-CN" altLang="en-US" sz="915" dirty="0"/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1094849" y="2553958"/>
                <a:ext cx="445293" cy="2324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45</a:t>
                </a:r>
                <a:endParaRPr lang="zh-CN" altLang="en-US" sz="915" dirty="0"/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1094849" y="3084328"/>
                <a:ext cx="445293" cy="2324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35</a:t>
                </a:r>
                <a:endParaRPr lang="zh-CN" altLang="en-US" sz="915" dirty="0"/>
              </a:p>
            </p:txBody>
          </p:sp>
        </p:grpSp>
      </p:grpSp>
      <p:pic>
        <p:nvPicPr>
          <p:cNvPr id="8" name="图片 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896" t="10126" r="2280" b="51683"/>
          <a:stretch>
            <a:fillRect/>
          </a:stretch>
        </p:blipFill>
        <p:spPr>
          <a:xfrm flipH="1" flipV="1">
            <a:off x="4206356" y="2294441"/>
            <a:ext cx="932982" cy="5487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209" t="53501" r="1986" b="8785"/>
          <a:stretch>
            <a:fillRect/>
          </a:stretch>
        </p:blipFill>
        <p:spPr>
          <a:xfrm flipH="1" flipV="1">
            <a:off x="4206356" y="1707939"/>
            <a:ext cx="932982" cy="548756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98" t="1" r="4345" b="42804"/>
          <a:stretch>
            <a:fillRect/>
          </a:stretch>
        </p:blipFill>
        <p:spPr>
          <a:xfrm flipH="1" flipV="1">
            <a:off x="5254993" y="2294441"/>
            <a:ext cx="932982" cy="54875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36" t="60461" r="4206" b="3086"/>
          <a:stretch>
            <a:fillRect/>
          </a:stretch>
        </p:blipFill>
        <p:spPr>
          <a:xfrm flipH="1" flipV="1">
            <a:off x="5254993" y="1707939"/>
            <a:ext cx="932982" cy="54875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899535" y="1584960"/>
            <a:ext cx="420370" cy="2324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5"/>
              <a:t>kDa</a:t>
            </a:r>
          </a:p>
        </p:txBody>
      </p:sp>
      <p:grpSp>
        <p:nvGrpSpPr>
          <p:cNvPr id="65" name="组合 64"/>
          <p:cNvGrpSpPr/>
          <p:nvPr/>
        </p:nvGrpSpPr>
        <p:grpSpPr>
          <a:xfrm>
            <a:off x="1009650" y="4156075"/>
            <a:ext cx="450038" cy="691845"/>
            <a:chOff x="1064855" y="2404743"/>
            <a:chExt cx="590461" cy="907667"/>
          </a:xfrm>
        </p:grpSpPr>
        <p:grpSp>
          <p:nvGrpSpPr>
            <p:cNvPr id="66" name="组合 65"/>
            <p:cNvGrpSpPr/>
            <p:nvPr/>
          </p:nvGrpSpPr>
          <p:grpSpPr>
            <a:xfrm>
              <a:off x="1446893" y="2550324"/>
              <a:ext cx="208423" cy="622546"/>
              <a:chOff x="1477291" y="2547011"/>
              <a:chExt cx="208423" cy="622546"/>
            </a:xfrm>
          </p:grpSpPr>
          <p:cxnSp>
            <p:nvCxnSpPr>
              <p:cNvPr id="76" name="直接连接符 75"/>
              <p:cNvCxnSpPr/>
              <p:nvPr/>
            </p:nvCxnSpPr>
            <p:spPr>
              <a:xfrm>
                <a:off x="1477291" y="254701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1477291" y="3169557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1477291" y="2718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7" name="组合 66"/>
            <p:cNvGrpSpPr/>
            <p:nvPr/>
          </p:nvGrpSpPr>
          <p:grpSpPr>
            <a:xfrm>
              <a:off x="1064855" y="2404743"/>
              <a:ext cx="445293" cy="907667"/>
              <a:chOff x="1064855" y="2404743"/>
              <a:chExt cx="445293" cy="907667"/>
            </a:xfrm>
          </p:grpSpPr>
          <p:sp>
            <p:nvSpPr>
              <p:cNvPr id="70" name="文本框 69"/>
              <p:cNvSpPr txBox="1"/>
              <p:nvPr/>
            </p:nvSpPr>
            <p:spPr>
              <a:xfrm>
                <a:off x="1064855" y="2404743"/>
                <a:ext cx="445293" cy="232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55</a:t>
                </a:r>
                <a:endParaRPr lang="zh-CN" altLang="en-US" sz="915" dirty="0"/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1064855" y="2585708"/>
                <a:ext cx="445293" cy="232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45</a:t>
                </a:r>
                <a:endParaRPr lang="zh-CN" altLang="en-US" sz="915" dirty="0"/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1064855" y="3080048"/>
                <a:ext cx="445293" cy="232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15" dirty="0"/>
                  <a:t>35</a:t>
                </a:r>
                <a:endParaRPr lang="zh-CN" altLang="en-US" sz="915" dirty="0"/>
              </a:p>
            </p:txBody>
          </p:sp>
        </p:grpSp>
      </p:grpSp>
      <p:pic>
        <p:nvPicPr>
          <p:cNvPr id="17" name="图片 1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05" t="-1148" r="5688" b="43897"/>
          <a:stretch>
            <a:fillRect/>
          </a:stretch>
        </p:blipFill>
        <p:spPr>
          <a:xfrm flipH="1" flipV="1">
            <a:off x="1257687" y="4328323"/>
            <a:ext cx="932982" cy="548756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10" t="-494" r="56287" b="53710"/>
          <a:stretch>
            <a:fillRect/>
          </a:stretch>
        </p:blipFill>
        <p:spPr>
          <a:xfrm flipH="1" flipV="1">
            <a:off x="2307776" y="3756339"/>
            <a:ext cx="932982" cy="548756"/>
          </a:xfrm>
          <a:prstGeom prst="rect">
            <a:avLst/>
          </a:prstGeom>
        </p:spPr>
      </p:pic>
      <p:grpSp>
        <p:nvGrpSpPr>
          <p:cNvPr id="79" name="组合 78"/>
          <p:cNvGrpSpPr/>
          <p:nvPr/>
        </p:nvGrpSpPr>
        <p:grpSpPr>
          <a:xfrm>
            <a:off x="3886198" y="4006215"/>
            <a:ext cx="511000" cy="474653"/>
            <a:chOff x="984871" y="2195193"/>
            <a:chExt cx="670445" cy="622970"/>
          </a:xfrm>
        </p:grpSpPr>
        <p:grpSp>
          <p:nvGrpSpPr>
            <p:cNvPr id="82" name="组合 81"/>
            <p:cNvGrpSpPr/>
            <p:nvPr/>
          </p:nvGrpSpPr>
          <p:grpSpPr>
            <a:xfrm>
              <a:off x="1446893" y="2340774"/>
              <a:ext cx="208423" cy="381000"/>
              <a:chOff x="1477291" y="2337461"/>
              <a:chExt cx="208423" cy="381000"/>
            </a:xfrm>
          </p:grpSpPr>
          <p:cxnSp>
            <p:nvCxnSpPr>
              <p:cNvPr id="89" name="直接连接符 88"/>
              <p:cNvCxnSpPr/>
              <p:nvPr/>
            </p:nvCxnSpPr>
            <p:spPr>
              <a:xfrm>
                <a:off x="1477291" y="2337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/>
              <p:cNvCxnSpPr/>
              <p:nvPr/>
            </p:nvCxnSpPr>
            <p:spPr>
              <a:xfrm>
                <a:off x="1477291" y="2718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组合 82"/>
            <p:cNvGrpSpPr/>
            <p:nvPr/>
          </p:nvGrpSpPr>
          <p:grpSpPr>
            <a:xfrm>
              <a:off x="984871" y="2195193"/>
              <a:ext cx="552274" cy="622970"/>
              <a:chOff x="984871" y="2195193"/>
              <a:chExt cx="552274" cy="622970"/>
            </a:xfrm>
          </p:grpSpPr>
          <p:sp>
            <p:nvSpPr>
              <p:cNvPr id="85" name="文本框 44"/>
              <p:cNvSpPr txBox="1"/>
              <p:nvPr/>
            </p:nvSpPr>
            <p:spPr>
              <a:xfrm>
                <a:off x="984871" y="2195193"/>
                <a:ext cx="549869" cy="4900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915" dirty="0"/>
                  <a:t>100</a:t>
                </a:r>
                <a:endParaRPr lang="zh-CN" altLang="en-US" sz="915" dirty="0"/>
              </a:p>
            </p:txBody>
          </p:sp>
          <p:sp>
            <p:nvSpPr>
              <p:cNvPr id="86" name="文本框 45"/>
              <p:cNvSpPr txBox="1"/>
              <p:nvPr/>
            </p:nvSpPr>
            <p:spPr>
              <a:xfrm>
                <a:off x="1091852" y="2585708"/>
                <a:ext cx="445293" cy="2324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915" dirty="0"/>
                  <a:t>55</a:t>
                </a:r>
                <a:endParaRPr lang="zh-CN" altLang="en-US" sz="915" dirty="0"/>
              </a:p>
            </p:txBody>
          </p:sp>
        </p:grpSp>
      </p:grpSp>
      <p:pic>
        <p:nvPicPr>
          <p:cNvPr id="20" name="图片 1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58" t="53359" r="3483" b="1257"/>
          <a:stretch>
            <a:fillRect/>
          </a:stretch>
        </p:blipFill>
        <p:spPr>
          <a:xfrm flipH="1" flipV="1">
            <a:off x="4212647" y="3756339"/>
            <a:ext cx="932982" cy="548756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72" t="22229" r="3271" b="8193"/>
          <a:stretch>
            <a:fillRect/>
          </a:stretch>
        </p:blipFill>
        <p:spPr>
          <a:xfrm flipH="1" flipV="1">
            <a:off x="4212647" y="4328323"/>
            <a:ext cx="932982" cy="548756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12" t="23790" r="43900" b="10909"/>
          <a:stretch>
            <a:fillRect/>
          </a:stretch>
        </p:blipFill>
        <p:spPr>
          <a:xfrm flipH="1" flipV="1">
            <a:off x="5254993" y="4328323"/>
            <a:ext cx="932982" cy="54875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908425" y="3634105"/>
            <a:ext cx="442595" cy="2324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5"/>
              <a:t>kDa</a:t>
            </a: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-1" r="54355" b="37194"/>
          <a:stretch>
            <a:fillRect/>
          </a:stretch>
        </p:blipFill>
        <p:spPr>
          <a:xfrm flipH="1" flipV="1">
            <a:off x="2307776" y="4328323"/>
            <a:ext cx="932982" cy="548756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951230" y="3614420"/>
            <a:ext cx="506730" cy="2324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5"/>
              <a:t>kDa</a:t>
            </a:r>
          </a:p>
        </p:txBody>
      </p:sp>
      <p:grpSp>
        <p:nvGrpSpPr>
          <p:cNvPr id="98" name="组合 97"/>
          <p:cNvGrpSpPr/>
          <p:nvPr/>
        </p:nvGrpSpPr>
        <p:grpSpPr>
          <a:xfrm>
            <a:off x="911222" y="5742937"/>
            <a:ext cx="541482" cy="1225397"/>
            <a:chOff x="944879" y="1658685"/>
            <a:chExt cx="710437" cy="1608063"/>
          </a:xfrm>
        </p:grpSpPr>
        <p:grpSp>
          <p:nvGrpSpPr>
            <p:cNvPr id="99" name="组合 98"/>
            <p:cNvGrpSpPr/>
            <p:nvPr/>
          </p:nvGrpSpPr>
          <p:grpSpPr>
            <a:xfrm>
              <a:off x="1446893" y="1870874"/>
              <a:ext cx="208423" cy="1301996"/>
              <a:chOff x="1477291" y="1867561"/>
              <a:chExt cx="208423" cy="1301996"/>
            </a:xfrm>
          </p:grpSpPr>
          <p:cxnSp>
            <p:nvCxnSpPr>
              <p:cNvPr id="106" name="直接连接符 105"/>
              <p:cNvCxnSpPr/>
              <p:nvPr/>
            </p:nvCxnSpPr>
            <p:spPr>
              <a:xfrm>
                <a:off x="1477291" y="18675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连接符 106"/>
              <p:cNvCxnSpPr/>
              <p:nvPr/>
            </p:nvCxnSpPr>
            <p:spPr>
              <a:xfrm>
                <a:off x="1477291" y="2337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/>
              <p:cNvCxnSpPr/>
              <p:nvPr/>
            </p:nvCxnSpPr>
            <p:spPr>
              <a:xfrm>
                <a:off x="1477291" y="3169557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直接连接符 108"/>
              <p:cNvCxnSpPr/>
              <p:nvPr/>
            </p:nvCxnSpPr>
            <p:spPr>
              <a:xfrm>
                <a:off x="1477291" y="2718461"/>
                <a:ext cx="2084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组合 99"/>
            <p:cNvGrpSpPr/>
            <p:nvPr/>
          </p:nvGrpSpPr>
          <p:grpSpPr>
            <a:xfrm>
              <a:off x="944879" y="1658685"/>
              <a:ext cx="569865" cy="1608063"/>
              <a:chOff x="944879" y="1658685"/>
              <a:chExt cx="569865" cy="1608063"/>
            </a:xfrm>
          </p:grpSpPr>
          <p:sp>
            <p:nvSpPr>
              <p:cNvPr id="101" name="文本框 43"/>
              <p:cNvSpPr txBox="1"/>
              <p:nvPr/>
            </p:nvSpPr>
            <p:spPr>
              <a:xfrm>
                <a:off x="944879" y="1658685"/>
                <a:ext cx="569865" cy="4899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915" dirty="0"/>
                  <a:t>100</a:t>
                </a:r>
                <a:endParaRPr lang="zh-CN" altLang="en-US" sz="915" dirty="0"/>
              </a:p>
            </p:txBody>
          </p:sp>
          <p:sp>
            <p:nvSpPr>
              <p:cNvPr id="102" name="文本框 44"/>
              <p:cNvSpPr txBox="1"/>
              <p:nvPr/>
            </p:nvSpPr>
            <p:spPr>
              <a:xfrm>
                <a:off x="1064855" y="2132813"/>
                <a:ext cx="445293" cy="2324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915" dirty="0"/>
                  <a:t>55</a:t>
                </a:r>
                <a:endParaRPr lang="zh-CN" altLang="en-US" sz="915" dirty="0"/>
              </a:p>
            </p:txBody>
          </p:sp>
          <p:sp>
            <p:nvSpPr>
              <p:cNvPr id="103" name="文本框 45"/>
              <p:cNvSpPr txBox="1"/>
              <p:nvPr/>
            </p:nvSpPr>
            <p:spPr>
              <a:xfrm>
                <a:off x="1064855" y="2585708"/>
                <a:ext cx="445293" cy="2324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915" dirty="0"/>
                  <a:t>45</a:t>
                </a:r>
                <a:endParaRPr lang="zh-CN" altLang="en-US" sz="915" dirty="0"/>
              </a:p>
            </p:txBody>
          </p:sp>
          <p:sp>
            <p:nvSpPr>
              <p:cNvPr id="105" name="文本框 46"/>
              <p:cNvSpPr txBox="1"/>
              <p:nvPr/>
            </p:nvSpPr>
            <p:spPr>
              <a:xfrm>
                <a:off x="1064855" y="3034328"/>
                <a:ext cx="445293" cy="2324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n-US" altLang="zh-CN" sz="915" dirty="0"/>
                  <a:t>35</a:t>
                </a:r>
                <a:endParaRPr lang="zh-CN" altLang="en-US" sz="915" dirty="0"/>
              </a:p>
            </p:txBody>
          </p:sp>
        </p:grpSp>
      </p:grpSp>
      <p:pic>
        <p:nvPicPr>
          <p:cNvPr id="24" name="图片 23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91" t="43584" r="3091" b="9912"/>
          <a:stretch>
            <a:fillRect/>
          </a:stretch>
        </p:blipFill>
        <p:spPr>
          <a:xfrm flipH="1" flipV="1">
            <a:off x="1257687" y="6412047"/>
            <a:ext cx="932982" cy="548756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0" t="-473" b="31169"/>
          <a:stretch>
            <a:fillRect/>
          </a:stretch>
        </p:blipFill>
        <p:spPr>
          <a:xfrm flipH="1" flipV="1">
            <a:off x="1257687" y="5794576"/>
            <a:ext cx="932982" cy="548756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13" t="42176" r="50297" b="8702"/>
          <a:stretch>
            <a:fillRect/>
          </a:stretch>
        </p:blipFill>
        <p:spPr>
          <a:xfrm flipH="1" flipV="1">
            <a:off x="2307776" y="6412047"/>
            <a:ext cx="932982" cy="548756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" t="5177" r="51332" b="23555"/>
          <a:stretch>
            <a:fillRect/>
          </a:stretch>
        </p:blipFill>
        <p:spPr>
          <a:xfrm flipH="1" flipV="1">
            <a:off x="2307776" y="5835224"/>
            <a:ext cx="932982" cy="548756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958850" y="5633085"/>
            <a:ext cx="455930" cy="2324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5"/>
              <a:t>kDa</a:t>
            </a:r>
          </a:p>
        </p:txBody>
      </p:sp>
      <p:graphicFrame>
        <p:nvGraphicFramePr>
          <p:cNvPr id="26" name="表格 25"/>
          <p:cNvGraphicFramePr/>
          <p:nvPr>
            <p:custDataLst>
              <p:tags r:id="rId5"/>
            </p:custDataLst>
          </p:nvPr>
        </p:nvGraphicFramePr>
        <p:xfrm>
          <a:off x="538897" y="2988408"/>
          <a:ext cx="2593340" cy="680720"/>
        </p:xfrm>
        <a:graphic>
          <a:graphicData uri="http://schemas.openxmlformats.org/drawingml/2006/table">
            <a:tbl>
              <a:tblPr/>
              <a:tblGrid>
                <a:gridCol w="10579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09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06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2448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305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587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sz="1065" dirty="0">
                          <a:sym typeface="+mn-ea"/>
                        </a:rPr>
                        <a:t>MAVS</a:t>
                      </a:r>
                      <a:r>
                        <a:rPr lang="en-US" altLang="el-GR" sz="1065" dirty="0">
                          <a:sym typeface="+mn-ea"/>
                        </a:rPr>
                        <a:t>-HA</a:t>
                      </a:r>
                      <a:endParaRPr lang="en-US" altLang="el-GR" sz="1065" b="0" i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13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2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ector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27" name="表格 26"/>
          <p:cNvGraphicFramePr/>
          <p:nvPr>
            <p:custDataLst>
              <p:tags r:id="rId6"/>
            </p:custDataLst>
          </p:nvPr>
        </p:nvGraphicFramePr>
        <p:xfrm>
          <a:off x="538897" y="983077"/>
          <a:ext cx="2680335" cy="708025"/>
        </p:xfrm>
        <a:graphic>
          <a:graphicData uri="http://schemas.openxmlformats.org/drawingml/2006/table">
            <a:tbl>
              <a:tblPr/>
              <a:tblGrid>
                <a:gridCol w="9639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43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66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561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654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5433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97485">
                <a:tc>
                  <a:txBody>
                    <a:bodyPr/>
                    <a:lstStyle/>
                    <a:p>
                      <a:pPr algn="l" fontAlgn="t"/>
                      <a:r>
                        <a:rPr lang="en-US" sz="1065" dirty="0">
                          <a:sym typeface="+mn-ea"/>
                        </a:rPr>
                        <a:t>RIG-I</a:t>
                      </a:r>
                      <a:r>
                        <a:rPr lang="en-US" altLang="el-GR" sz="1065" dirty="0">
                          <a:sym typeface="+mn-ea"/>
                        </a:rPr>
                        <a:t>-HA</a:t>
                      </a:r>
                      <a:endParaRPr lang="en-US" altLang="el-GR" sz="1065" b="0" i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13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USP17L2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0180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ector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sz="1065" b="0" i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065" b="0" i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7500" marR="7500" marT="750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16" name="图片 15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99" t="153" r="6370" b="52143"/>
          <a:stretch>
            <a:fillRect/>
          </a:stretch>
        </p:blipFill>
        <p:spPr>
          <a:xfrm flipH="1" flipV="1">
            <a:off x="1257687" y="3756339"/>
            <a:ext cx="932982" cy="548756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293*103"/>
  <p:tag name="TABLE_ENDDRAG_RECT" val="54*540*293*103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293*103"/>
  <p:tag name="TABLE_ENDDRAG_RECT" val="54*540*293*103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293*103"/>
  <p:tag name="TABLE_ENDDRAG_RECT" val="54*540*293*103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293*103"/>
  <p:tag name="TABLE_ENDDRAG_RECT" val="54*540*293*103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293*103"/>
  <p:tag name="TABLE_ENDDRAG_RECT" val="54*540*293*103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1</Words>
  <Application>Microsoft Office PowerPoint</Application>
  <PresentationFormat>Custom</PresentationFormat>
  <Paragraphs>198</Paragraphs>
  <Slides>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Wingdings</vt:lpstr>
      <vt:lpstr>WPS</vt:lpstr>
      <vt:lpstr>Prism 10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秦辰</dc:creator>
  <cp:lastModifiedBy>MDPI</cp:lastModifiedBy>
  <cp:revision>201</cp:revision>
  <dcterms:created xsi:type="dcterms:W3CDTF">2019-06-19T02:08:00Z</dcterms:created>
  <dcterms:modified xsi:type="dcterms:W3CDTF">2026-05-20T06:19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A538CEB1E2574FA0B2D83B63E362EAC3_13</vt:lpwstr>
  </property>
</Properties>
</file>